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267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 l="4222" t="14389" r="2304" b="7671"/>
          <a:stretch>
            <a:fillRect/>
          </a:stretch>
        </p:blipFill>
        <p:spPr bwMode="auto">
          <a:xfrm rot="16200000">
            <a:off x="-590263" y="2254561"/>
            <a:ext cx="8064897" cy="42028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260648" y="251520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ure S5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6672" y="539552"/>
            <a:ext cx="554461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5: Gene ontology enrichment analysis of maize genes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downregulated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by the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tin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mutants and the cluster 19A deletion at 4 dpi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GOEAST software toolkit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[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43]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used to identify GO terms for cellular processes that are enriched in maize leaves infected with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U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aydi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rain SG200∆19A and the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utants compared to mock-treated samples. Yellow boxes indicate processes enriched in both SG200∆19A and the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ti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utants infected samples. Darker color shades indicate higher significance of enrichment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values are indicated in brackets. </a:t>
            </a: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8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cp:lastModifiedBy>tanaka</cp:lastModifiedBy>
  <cp:revision>2</cp:revision>
  <dcterms:modified xsi:type="dcterms:W3CDTF">2014-05-15T12:15:13Z</dcterms:modified>
</cp:coreProperties>
</file>